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694"/>
  </p:normalViewPr>
  <p:slideViewPr>
    <p:cSldViewPr snapToGrid="0" snapToObjects="1">
      <p:cViewPr varScale="1">
        <p:scale>
          <a:sx n="108" d="100"/>
          <a:sy n="108" d="100"/>
        </p:scale>
        <p:origin x="59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F66E6EF-17C2-0149-AACE-A42F1DAF038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5D56486B-5C32-9A4A-8773-A4DF419FE03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B51F83E-CDD1-1B45-8AF9-5FA72B6550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B98ADF-53C4-2F49-A51F-2D49FF88590F}" type="datetimeFigureOut">
              <a:rPr lang="it-IT" smtClean="0"/>
              <a:t>26/12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48F40A6-6056-AA4A-867F-CB2508806C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A09979F-6E6D-8544-9BBF-CE1A866EFB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251D9-57A1-7141-BF1D-B29204C1E08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060280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4CAA59B-C47C-314D-BA04-59E1D4EB48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D9CAC1AA-0DE4-7C41-8822-4E5F711988F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FF101A8-C3DA-1745-B7A3-DEA0361E63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B98ADF-53C4-2F49-A51F-2D49FF88590F}" type="datetimeFigureOut">
              <a:rPr lang="it-IT" smtClean="0"/>
              <a:t>26/12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D8FF091-335B-C041-A61E-7ED64943F0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472B35A-6D33-D94F-995B-1136DEC3CE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251D9-57A1-7141-BF1D-B29204C1E08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4618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6B4101BF-907E-1A42-AB99-EB36A122C59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D61373B9-9226-C34F-8358-3A589B77B52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DF85131-4395-F94D-A7E3-74FDA2B4CD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B98ADF-53C4-2F49-A51F-2D49FF88590F}" type="datetimeFigureOut">
              <a:rPr lang="it-IT" smtClean="0"/>
              <a:t>26/12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59B0076-1A6D-E341-AD14-50F199279A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672FB7A-C3E5-BD49-9C86-06A20A2BA1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251D9-57A1-7141-BF1D-B29204C1E08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232959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176A38A-C71E-9641-B579-886C7A6EDE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89F83934-3C73-1545-8F16-2D2324A0A27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BD35DF1-0C79-7C4B-8353-F2E381A5CD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B98ADF-53C4-2F49-A51F-2D49FF88590F}" type="datetimeFigureOut">
              <a:rPr lang="it-IT" smtClean="0"/>
              <a:t>26/12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5F1E396-B60C-484A-914C-2CFF66BCCE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72FE73A-9E67-E14D-8074-059AE35055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251D9-57A1-7141-BF1D-B29204C1E08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124351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68B681A-4949-DF44-AA8E-664D50E167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68C1480-F5DC-2A44-88A7-F85121F1E6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E4A7581-9054-B840-96D5-8BC2F47DD8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B98ADF-53C4-2F49-A51F-2D49FF88590F}" type="datetimeFigureOut">
              <a:rPr lang="it-IT" smtClean="0"/>
              <a:t>26/12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A8748C4-AEC3-AF4B-8A1B-06C8DDF057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4BF03AE-476D-D94A-8F6C-0286C6F307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251D9-57A1-7141-BF1D-B29204C1E08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677711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B89342A-0E91-F349-B944-962851176F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2CCA95B7-4127-6F46-B61B-FCF44F4636F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8A023772-4084-7E45-A242-8AD1968FB91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8C4126FA-7D3B-A54D-BE5F-6A71A53400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B98ADF-53C4-2F49-A51F-2D49FF88590F}" type="datetimeFigureOut">
              <a:rPr lang="it-IT" smtClean="0"/>
              <a:t>26/12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DF5EE936-BC00-0E4A-8513-55E12B8E2B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DEECA661-4256-F045-B24D-06CEC9471E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251D9-57A1-7141-BF1D-B29204C1E08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234450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C572D4D-EEDD-F04B-9702-5D8A895D01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A7F1FD45-9BB0-E742-9C38-93C446C95E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6150FC0B-3D5E-224B-B4F9-298601370D1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83A4AA9C-75D0-3B4C-A62A-77BF4E5A002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C5390003-5756-2C48-AB2C-E67E8292D80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DD19CA1B-E6C0-544F-A714-00EA502A61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B98ADF-53C4-2F49-A51F-2D49FF88590F}" type="datetimeFigureOut">
              <a:rPr lang="it-IT" smtClean="0"/>
              <a:t>26/12/2021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EBF80E9E-7BC7-C841-905F-DF767E0234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71BFAECF-8B84-4847-B15E-5747277FC3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251D9-57A1-7141-BF1D-B29204C1E08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67842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A2913BB-8499-CF46-89E1-23C6C0363F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1E23F43B-08DC-6A40-B2D9-F3EC5D220D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B98ADF-53C4-2F49-A51F-2D49FF88590F}" type="datetimeFigureOut">
              <a:rPr lang="it-IT" smtClean="0"/>
              <a:t>26/12/2021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D488698A-B60A-1741-851D-C469EACBC2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60375D15-C485-804E-9CBA-7C1A446683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251D9-57A1-7141-BF1D-B29204C1E08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052782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D6BF79E1-ED7A-5047-958D-5AB7244712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B98ADF-53C4-2F49-A51F-2D49FF88590F}" type="datetimeFigureOut">
              <a:rPr lang="it-IT" smtClean="0"/>
              <a:t>26/12/2021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5153786E-42D2-914B-A39F-5DFA484EEC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CB93029E-0B60-CB40-91F0-3089F1B991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251D9-57A1-7141-BF1D-B29204C1E08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906203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5E6A6EF-2756-7141-B53F-6E28CC8CF9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3F8BD0A2-8FDF-0141-BA0B-DE8EEE48230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B4463EE4-2049-2841-8D97-9B2D3989AD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B8F0086F-A477-554A-BE12-A7FF83E430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B98ADF-53C4-2F49-A51F-2D49FF88590F}" type="datetimeFigureOut">
              <a:rPr lang="it-IT" smtClean="0"/>
              <a:t>26/12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B3C8BBD4-46F1-5449-91D2-0EA9EB368E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ABD313F1-051B-5440-82A8-5F1003D14A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251D9-57A1-7141-BF1D-B29204C1E08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872206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C33694C-D078-B143-8561-8890B04FF2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B1FC9C75-82E4-8C48-8252-F58D76FE778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D7304DFB-4230-E845-B6E0-3FDEC34893E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10A52FF6-B24A-2A4C-813A-A36CBA1E2C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B98ADF-53C4-2F49-A51F-2D49FF88590F}" type="datetimeFigureOut">
              <a:rPr lang="it-IT" smtClean="0"/>
              <a:t>26/12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ABD42330-E785-F24C-B069-4970471EDB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284E8245-BBB1-A846-A031-B455EF19D9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251D9-57A1-7141-BF1D-B29204C1E08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147973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E87C9A24-FFF5-5E42-A77E-9E18DBD058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9C6736BB-3BE2-124E-9145-A7FB139F5B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91D883B-C639-7841-8281-BC57124704C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B98ADF-53C4-2F49-A51F-2D49FF88590F}" type="datetimeFigureOut">
              <a:rPr lang="it-IT" smtClean="0"/>
              <a:t>26/12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8727081-5ADF-424D-A70B-20A634B797A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6E9FF19-2C3E-AB4F-8C8B-68573DDB629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0251D9-57A1-7141-BF1D-B29204C1E08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529758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 descr="Immagine che contiene testo&#10;&#10;Descrizione generata automaticamente">
            <a:extLst>
              <a:ext uri="{FF2B5EF4-FFF2-40B4-BE49-F238E27FC236}">
                <a16:creationId xmlns:a16="http://schemas.microsoft.com/office/drawing/2014/main" id="{84F129BB-C99D-4748-B416-CD44A8C7B0B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27855" y="170996"/>
            <a:ext cx="2536290" cy="6145306"/>
          </a:xfrm>
          <a:prstGeom prst="rect">
            <a:avLst/>
          </a:prstGeom>
        </p:spPr>
      </p:pic>
      <p:pic>
        <p:nvPicPr>
          <p:cNvPr id="5" name="Immagine 4" descr="Immagine che contiene tavolo&#10;&#10;Descrizione generata automaticamente">
            <a:extLst>
              <a:ext uri="{FF2B5EF4-FFF2-40B4-BE49-F238E27FC236}">
                <a16:creationId xmlns:a16="http://schemas.microsoft.com/office/drawing/2014/main" id="{0149B49C-B878-E94A-BD8E-0837318E6DF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4025" r="74334"/>
          <a:stretch/>
        </p:blipFill>
        <p:spPr>
          <a:xfrm>
            <a:off x="7591237" y="159391"/>
            <a:ext cx="1022545" cy="2152184"/>
          </a:xfrm>
          <a:prstGeom prst="rect">
            <a:avLst/>
          </a:prstGeom>
        </p:spPr>
      </p:pic>
      <p:sp>
        <p:nvSpPr>
          <p:cNvPr id="6" name="CasellaDiTesto 5">
            <a:extLst>
              <a:ext uri="{FF2B5EF4-FFF2-40B4-BE49-F238E27FC236}">
                <a16:creationId xmlns:a16="http://schemas.microsoft.com/office/drawing/2014/main" id="{6DFA9E4E-D4B5-425C-AD20-9D8CE1834707}"/>
              </a:ext>
            </a:extLst>
          </p:cNvPr>
          <p:cNvSpPr txBox="1"/>
          <p:nvPr/>
        </p:nvSpPr>
        <p:spPr>
          <a:xfrm>
            <a:off x="8561737" y="1940908"/>
            <a:ext cx="59182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/>
              <a:t>Level 1</a:t>
            </a:r>
            <a:endParaRPr lang="en-GB" sz="1100" b="1" dirty="0"/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0B71F464-98BC-4E4A-9B39-2B63E73C174D}"/>
              </a:ext>
            </a:extLst>
          </p:cNvPr>
          <p:cNvSpPr txBox="1"/>
          <p:nvPr/>
        </p:nvSpPr>
        <p:spPr>
          <a:xfrm>
            <a:off x="8561737" y="1707414"/>
            <a:ext cx="59182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/>
              <a:t>Level 2</a:t>
            </a:r>
            <a:endParaRPr lang="en-GB" sz="1100" b="1" dirty="0"/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A2227132-7DE2-44CB-986B-29208EC4A2FA}"/>
              </a:ext>
            </a:extLst>
          </p:cNvPr>
          <p:cNvSpPr txBox="1"/>
          <p:nvPr/>
        </p:nvSpPr>
        <p:spPr>
          <a:xfrm>
            <a:off x="8561737" y="1489311"/>
            <a:ext cx="59182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/>
              <a:t>Level 3</a:t>
            </a:r>
            <a:endParaRPr lang="en-GB" sz="1100" b="1" dirty="0"/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1C656DD7-C704-4313-BC17-DCF0F72D9413}"/>
              </a:ext>
            </a:extLst>
          </p:cNvPr>
          <p:cNvSpPr txBox="1"/>
          <p:nvPr/>
        </p:nvSpPr>
        <p:spPr>
          <a:xfrm>
            <a:off x="8561737" y="1263513"/>
            <a:ext cx="59182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/>
              <a:t>Level 4</a:t>
            </a:r>
            <a:endParaRPr lang="en-GB" sz="1100" b="1" dirty="0"/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E6263A03-8DB6-4AE3-82C7-F92F4780AD45}"/>
              </a:ext>
            </a:extLst>
          </p:cNvPr>
          <p:cNvSpPr txBox="1"/>
          <p:nvPr/>
        </p:nvSpPr>
        <p:spPr>
          <a:xfrm>
            <a:off x="8561737" y="1046103"/>
            <a:ext cx="59182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/>
              <a:t>Level 5</a:t>
            </a:r>
            <a:endParaRPr lang="en-GB" sz="1100" b="1" dirty="0"/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29C0C090-4511-4090-BAB6-6AA857654B2D}"/>
              </a:ext>
            </a:extLst>
          </p:cNvPr>
          <p:cNvSpPr txBox="1"/>
          <p:nvPr/>
        </p:nvSpPr>
        <p:spPr>
          <a:xfrm>
            <a:off x="8561737" y="812609"/>
            <a:ext cx="59182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/>
              <a:t>Level 6</a:t>
            </a:r>
            <a:endParaRPr lang="en-GB" sz="1100" b="1" dirty="0"/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F90E8BEA-25E8-4177-80C8-18E9B65D8717}"/>
              </a:ext>
            </a:extLst>
          </p:cNvPr>
          <p:cNvSpPr txBox="1"/>
          <p:nvPr/>
        </p:nvSpPr>
        <p:spPr>
          <a:xfrm>
            <a:off x="8561737" y="594506"/>
            <a:ext cx="59182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/>
              <a:t>Level 7</a:t>
            </a:r>
            <a:endParaRPr lang="en-GB" sz="1100" b="1" dirty="0"/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AF66F440-EAF5-4BFB-8815-276FFC71A7CB}"/>
              </a:ext>
            </a:extLst>
          </p:cNvPr>
          <p:cNvSpPr txBox="1"/>
          <p:nvPr/>
        </p:nvSpPr>
        <p:spPr>
          <a:xfrm>
            <a:off x="8561737" y="368708"/>
            <a:ext cx="59182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/>
              <a:t>Level 8</a:t>
            </a:r>
            <a:endParaRPr lang="en-GB" sz="1100" b="1" dirty="0"/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1F858404-2970-47FC-9962-56AAFB7659A4}"/>
              </a:ext>
            </a:extLst>
          </p:cNvPr>
          <p:cNvSpPr txBox="1"/>
          <p:nvPr/>
        </p:nvSpPr>
        <p:spPr>
          <a:xfrm>
            <a:off x="8561737" y="142910"/>
            <a:ext cx="59182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/>
              <a:t>Level 9</a:t>
            </a:r>
            <a:endParaRPr lang="en-GB" sz="1100" b="1" dirty="0"/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E6DF807A-1889-4367-8405-7745E2A0292F}"/>
              </a:ext>
            </a:extLst>
          </p:cNvPr>
          <p:cNvSpPr txBox="1"/>
          <p:nvPr/>
        </p:nvSpPr>
        <p:spPr>
          <a:xfrm>
            <a:off x="212431" y="6396335"/>
            <a:ext cx="1183456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cs typeface="Times New Roman" panose="02020603050405020304" pitchFamily="18" charset="0"/>
              </a:rPr>
              <a:t>Figure S5: </a:t>
            </a:r>
            <a:r>
              <a:rPr lang="en-US" sz="1200" dirty="0">
                <a:cs typeface="Times New Roman" panose="02020603050405020304" pitchFamily="18" charset="0"/>
              </a:rPr>
              <a:t>GO enrichment analysis of heterozygous variants identified in CDT. Each box shows the GO term number, the p-value in parentheses, and GO term. Box colors indicate levels of statistical significance</a:t>
            </a:r>
          </a:p>
        </p:txBody>
      </p:sp>
    </p:spTree>
    <p:extLst>
      <p:ext uri="{BB962C8B-B14F-4D97-AF65-F5344CB8AC3E}">
        <p14:creationId xmlns:p14="http://schemas.microsoft.com/office/powerpoint/2010/main" val="74740828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</TotalTime>
  <Words>55</Words>
  <Application>Microsoft Office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alvatore esposito</dc:creator>
  <cp:lastModifiedBy>pasquale tripodi</cp:lastModifiedBy>
  <cp:revision>11</cp:revision>
  <dcterms:created xsi:type="dcterms:W3CDTF">2021-07-01T13:08:19Z</dcterms:created>
  <dcterms:modified xsi:type="dcterms:W3CDTF">2021-12-26T14:43:15Z</dcterms:modified>
</cp:coreProperties>
</file>